
<file path=[Content_Types].xml><?xml version="1.0" encoding="utf-8"?>
<Types xmlns="http://schemas.openxmlformats.org/package/2006/content-types">
  <Default Extension="jpeg" ContentType="image/jpeg"/>
  <Default Extension="mp4" ContentType="video/mp4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  <Override PartName="/docMetadata/LabelInfo.xml" ContentType="application/vnd.ms-office.classificationlabel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microsoft.com/office/2020/02/relationships/classificationlabels" Target="docMetadata/LabelInfo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08" r:id="rId1"/>
  </p:sldMasterIdLst>
  <p:notesMasterIdLst>
    <p:notesMasterId r:id="rId3"/>
  </p:notesMasterIdLst>
  <p:sldIdLst>
    <p:sldId id="274" r:id="rId2"/>
  </p:sldIdLst>
  <p:sldSz cx="6858000" cy="12192000"/>
  <p:notesSz cx="6797675" cy="9926638"/>
  <p:custDataLst>
    <p:tags r:id="rId4"/>
  </p:custDataLst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6622CE46-714A-2389-C8AB-70D953A9AC07}" name="语涵 高" initials="语高" userId="5f00a61f6cc9aa16" providerId="Windows Live"/>
  <p188:author id="{E29A914A-CBB8-5F50-7A11-9AAE5B6B7422}" name="Yuhan Gao" initials="YG" userId="S::40281476@ads.qub.ac.uk::8d8adcf0-61cd-47ea-8216-d601a2472f46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99FF"/>
    <a:srgbClr val="0000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82C2AD0F-6995-491D-A83D-C4DC83024F5C}" v="1" dt="2025-09-15T12:06:39.701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57" d="100"/>
          <a:sy n="57" d="100"/>
        </p:scale>
        <p:origin x="297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11" Type="http://schemas.microsoft.com/office/2018/10/relationships/authors" Target="authors.xml"/><Relationship Id="rId5" Type="http://schemas.openxmlformats.org/officeDocument/2006/relationships/presProps" Target="presProps.xml"/><Relationship Id="rId10" Type="http://schemas.microsoft.com/office/2015/10/relationships/revisionInfo" Target="revisionInfo.xml"/><Relationship Id="rId4" Type="http://schemas.openxmlformats.org/officeDocument/2006/relationships/tags" Target="tags/tag1.xml"/><Relationship Id="rId9" Type="http://schemas.microsoft.com/office/2016/11/relationships/changesInfo" Target="changesInfos/changesInfo1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Derek Brazil" userId="c47ad072-068a-4d92-9836-2ea0c48e93a3" providerId="ADAL" clId="{9204C5A2-BEEE-4234-AA8C-32B26ECD591F}"/>
    <pc:docChg chg="custSel modSld">
      <pc:chgData name="Derek Brazil" userId="c47ad072-068a-4d92-9836-2ea0c48e93a3" providerId="ADAL" clId="{9204C5A2-BEEE-4234-AA8C-32B26ECD591F}" dt="2025-09-15T12:06:39.701" v="10"/>
      <pc:docMkLst>
        <pc:docMk/>
      </pc:docMkLst>
      <pc:sldChg chg="addSp delSp modSp mod">
        <pc:chgData name="Derek Brazil" userId="c47ad072-068a-4d92-9836-2ea0c48e93a3" providerId="ADAL" clId="{9204C5A2-BEEE-4234-AA8C-32B26ECD591F}" dt="2025-09-15T12:06:39.701" v="10"/>
        <pc:sldMkLst>
          <pc:docMk/>
          <pc:sldMk cId="4109778556" sldId="274"/>
        </pc:sldMkLst>
        <pc:spChg chg="add mod">
          <ac:chgData name="Derek Brazil" userId="c47ad072-068a-4d92-9836-2ea0c48e93a3" providerId="ADAL" clId="{9204C5A2-BEEE-4234-AA8C-32B26ECD591F}" dt="2025-09-15T12:05:42.329" v="9" actId="1076"/>
          <ac:spMkLst>
            <pc:docMk/>
            <pc:sldMk cId="4109778556" sldId="274"/>
            <ac:spMk id="3" creationId="{588DB7B3-A615-768F-9207-5C92FDC72A87}"/>
          </ac:spMkLst>
        </pc:spChg>
        <pc:spChg chg="del">
          <ac:chgData name="Derek Brazil" userId="c47ad072-068a-4d92-9836-2ea0c48e93a3" providerId="ADAL" clId="{9204C5A2-BEEE-4234-AA8C-32B26ECD591F}" dt="2025-09-15T12:05:24.799" v="7" actId="478"/>
          <ac:spMkLst>
            <pc:docMk/>
            <pc:sldMk cId="4109778556" sldId="274"/>
            <ac:spMk id="7" creationId="{8B8A8BCC-FE6C-FDA9-872A-76D792BDECCB}"/>
          </ac:spMkLst>
        </pc:spChg>
        <pc:picChg chg="mod">
          <ac:chgData name="Derek Brazil" userId="c47ad072-068a-4d92-9836-2ea0c48e93a3" providerId="ADAL" clId="{9204C5A2-BEEE-4234-AA8C-32B26ECD591F}" dt="2025-09-15T12:06:39.701" v="10"/>
          <ac:picMkLst>
            <pc:docMk/>
            <pc:sldMk cId="4109778556" sldId="274"/>
            <ac:picMk id="4" creationId="{65B16FA5-598C-7A26-F74E-1E4F87D4C346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8056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57C72CC3-63D8-4D37-BFF3-B9FF4DF2E4DB}" type="datetimeFigureOut">
              <a:rPr lang="en-GB" smtClean="0"/>
              <a:t>15/09/2025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457450" y="1241425"/>
            <a:ext cx="1882775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9768" y="4777194"/>
            <a:ext cx="5438140" cy="390861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50443" y="9428584"/>
            <a:ext cx="2945659" cy="498055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7AE512F-1830-4880-AECA-072BD9CFF25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633797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995312"/>
            <a:ext cx="5829300" cy="4244622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6403623"/>
            <a:ext cx="5143500" cy="29435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70CC6-8C24-4DE7-86CD-FECC7CD5C694}" type="datetimeFigureOut">
              <a:rPr lang="en-GB" smtClean="0"/>
              <a:t>15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FFB0C-A934-4E58-925A-4FDB6BFA97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877364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70CC6-8C24-4DE7-86CD-FECC7CD5C694}" type="datetimeFigureOut">
              <a:rPr lang="en-GB" smtClean="0"/>
              <a:t>15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FFB0C-A934-4E58-925A-4FDB6BFA97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88511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649111"/>
            <a:ext cx="1478756" cy="10332156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649111"/>
            <a:ext cx="4350544" cy="10332156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70CC6-8C24-4DE7-86CD-FECC7CD5C694}" type="datetimeFigureOut">
              <a:rPr lang="en-GB" smtClean="0"/>
              <a:t>15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FFB0C-A934-4E58-925A-4FDB6BFA97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197864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70CC6-8C24-4DE7-86CD-FECC7CD5C694}" type="datetimeFigureOut">
              <a:rPr lang="en-GB" smtClean="0"/>
              <a:t>15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FFB0C-A934-4E58-925A-4FDB6BFA97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845130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3039537"/>
            <a:ext cx="5915025" cy="507153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8159048"/>
            <a:ext cx="5915025" cy="266699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70CC6-8C24-4DE7-86CD-FECC7CD5C694}" type="datetimeFigureOut">
              <a:rPr lang="en-GB" smtClean="0"/>
              <a:t>15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FFB0C-A934-4E58-925A-4FDB6BFA97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5702943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3245556"/>
            <a:ext cx="2914650" cy="773571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70CC6-8C24-4DE7-86CD-FECC7CD5C694}" type="datetimeFigureOut">
              <a:rPr lang="en-GB" smtClean="0"/>
              <a:t>15/09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FFB0C-A934-4E58-925A-4FDB6BFA97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778805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49114"/>
            <a:ext cx="5915025" cy="2356556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988734"/>
            <a:ext cx="2901255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4453467"/>
            <a:ext cx="2901255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988734"/>
            <a:ext cx="2915543" cy="1464732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4453467"/>
            <a:ext cx="2915543" cy="6550379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70CC6-8C24-4DE7-86CD-FECC7CD5C694}" type="datetimeFigureOut">
              <a:rPr lang="en-GB" smtClean="0"/>
              <a:t>15/09/2025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FFB0C-A934-4E58-925A-4FDB6BFA97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7936183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70CC6-8C24-4DE7-86CD-FECC7CD5C694}" type="datetimeFigureOut">
              <a:rPr lang="en-GB" smtClean="0"/>
              <a:t>15/09/2025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FFB0C-A934-4E58-925A-4FDB6BFA97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09076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70CC6-8C24-4DE7-86CD-FECC7CD5C694}" type="datetimeFigureOut">
              <a:rPr lang="en-GB" smtClean="0"/>
              <a:t>15/09/2025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FFB0C-A934-4E58-925A-4FDB6BFA97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4663475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755425"/>
            <a:ext cx="3471863" cy="8664222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70CC6-8C24-4DE7-86CD-FECC7CD5C694}" type="datetimeFigureOut">
              <a:rPr lang="en-GB" smtClean="0"/>
              <a:t>15/09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FFB0C-A934-4E58-925A-4FDB6BFA97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642733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812800"/>
            <a:ext cx="2211884" cy="28448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755425"/>
            <a:ext cx="3471863" cy="8664222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3657600"/>
            <a:ext cx="2211884" cy="677615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0570CC6-8C24-4DE7-86CD-FECC7CD5C694}" type="datetimeFigureOut">
              <a:rPr lang="en-GB" smtClean="0"/>
              <a:t>15/09/2025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ABFFB0C-A934-4E58-925A-4FDB6BFA97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5423081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649114"/>
            <a:ext cx="5915025" cy="235655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3245556"/>
            <a:ext cx="5915025" cy="773571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00570CC6-8C24-4DE7-86CD-FECC7CD5C694}" type="datetimeFigureOut">
              <a:rPr lang="en-GB" smtClean="0"/>
              <a:t>15/09/2025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11300181"/>
            <a:ext cx="2314575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11300181"/>
            <a:ext cx="1543050" cy="649111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2ABFFB0C-A934-4E58-925A-4FDB6BFA973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158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09" r:id="rId1"/>
    <p:sldLayoutId id="2147483710" r:id="rId2"/>
    <p:sldLayoutId id="2147483711" r:id="rId3"/>
    <p:sldLayoutId id="2147483712" r:id="rId4"/>
    <p:sldLayoutId id="2147483713" r:id="rId5"/>
    <p:sldLayoutId id="2147483714" r:id="rId6"/>
    <p:sldLayoutId id="2147483715" r:id="rId7"/>
    <p:sldLayoutId id="2147483716" r:id="rId8"/>
    <p:sldLayoutId id="2147483717" r:id="rId9"/>
    <p:sldLayoutId id="2147483718" r:id="rId10"/>
    <p:sldLayoutId id="2147483719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2.xml"/><Relationship Id="rId2" Type="http://schemas.openxmlformats.org/officeDocument/2006/relationships/video" Target="../media/media1.mp4"/><Relationship Id="rId1" Type="http://schemas.microsoft.com/office/2007/relationships/media" Target="../media/media1.mp4"/><Relationship Id="rId4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live cell imaging video">
            <a:hlinkClick r:id="" action="ppaction://media"/>
            <a:extLst>
              <a:ext uri="{FF2B5EF4-FFF2-40B4-BE49-F238E27FC236}">
                <a16:creationId xmlns:a16="http://schemas.microsoft.com/office/drawing/2014/main" id="{65B16FA5-598C-7A26-F74E-1E4F87D4C346}"/>
              </a:ext>
            </a:extLst>
          </p:cNvPr>
          <p:cNvPicPr>
            <a:picLocks noChangeAspect="1"/>
          </p:cNvPicPr>
          <p:nvPr>
            <a:videoFile r:link="rId2"/>
            <p:extLst>
              <p:ext uri="{DAA4B4D4-6D71-4841-9C94-3DE7FCFB9230}">
                <p14:media xmlns:p14="http://schemas.microsoft.com/office/powerpoint/2010/main" r:embed="rId1"/>
              </p:ext>
            </p:extLst>
          </p:nvPr>
        </p:nvPicPr>
        <p:blipFill>
          <a:blip r:embed="rId4">
            <a:lum contrast="-20000"/>
          </a:blip>
          <a:stretch>
            <a:fillRect/>
          </a:stretch>
        </p:blipFill>
        <p:spPr>
          <a:xfrm>
            <a:off x="1296092" y="3963092"/>
            <a:ext cx="4265815" cy="426581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588DB7B3-A615-768F-9207-5C92FDC72A87}"/>
              </a:ext>
            </a:extLst>
          </p:cNvPr>
          <p:cNvSpPr txBox="1"/>
          <p:nvPr/>
        </p:nvSpPr>
        <p:spPr>
          <a:xfrm>
            <a:off x="135683" y="8563667"/>
            <a:ext cx="6586632" cy="167225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  <a:buNone/>
            </a:pPr>
            <a:r>
              <a:rPr lang="en-GB" sz="1600" b="1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Supporting Video file</a:t>
            </a:r>
            <a:endParaRPr lang="en-GB" sz="1600" dirty="0">
              <a:effectLst/>
              <a:latin typeface="Aptos" panose="020B000402020202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  <a:p>
            <a:pPr algn="just">
              <a:spcAft>
                <a:spcPts val="800"/>
              </a:spcAft>
              <a:buNone/>
            </a:pPr>
            <a:r>
              <a:rPr lang="en-GB" sz="16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HCT116 cells were treated with GREM1-FITC (1 </a:t>
            </a:r>
            <a:r>
              <a:rPr lang="en-GB" sz="1600" dirty="0">
                <a:effectLst/>
                <a:latin typeface="Symbol" panose="05050102010706020507" pitchFamily="18" charset="2"/>
                <a:ea typeface="SimSun" panose="02010600030101010101" pitchFamily="2" charset="-122"/>
                <a:cs typeface="Arial" panose="020B0604020202020204" pitchFamily="34" charset="0"/>
              </a:rPr>
              <a:t>m</a:t>
            </a:r>
            <a:r>
              <a:rPr lang="en-GB" sz="16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g/ml) overnight. Fluorescence images were captured every 30 min on a Nikon 6D live-cell imaging microscope. Exported images at the indicated times were used to compile a video to demonstrate GREM1-FITC uptake and localization over time. Scale bars, 50 </a:t>
            </a:r>
            <a:r>
              <a:rPr lang="en-GB" sz="1600" dirty="0">
                <a:effectLst/>
                <a:latin typeface="Symbol" panose="05050102010706020507" pitchFamily="18" charset="2"/>
                <a:ea typeface="SimSun" panose="02010600030101010101" pitchFamily="2" charset="-122"/>
                <a:cs typeface="Arial" panose="020B0604020202020204" pitchFamily="34" charset="0"/>
              </a:rPr>
              <a:t>m</a:t>
            </a:r>
            <a:r>
              <a:rPr lang="en-GB" sz="1600" dirty="0">
                <a:effectLst/>
                <a:latin typeface="Arial" panose="020B0604020202020204" pitchFamily="34" charset="0"/>
                <a:ea typeface="SimSun" panose="02010600030101010101" pitchFamily="2" charset="-122"/>
                <a:cs typeface="Times New Roman" panose="02020603050405020304" pitchFamily="18" charset="0"/>
              </a:rPr>
              <a:t>m.</a:t>
            </a:r>
            <a:endParaRPr lang="en-GB" sz="1600" dirty="0">
              <a:effectLst/>
              <a:latin typeface="Aptos" panose="020B0004020202020204" pitchFamily="34" charset="0"/>
              <a:ea typeface="SimSu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09778556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playFrom(0.0)">
                                      <p:cBhvr>
                                        <p:cTn id="6" dur="11000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  <p:video>
              <p:cMediaNode vol="80000">
                <p:cTn id="7" fill="hold" display="0">
                  <p:stCondLst>
                    <p:cond delay="indefinite"/>
                  </p:stCondLst>
                </p:cTn>
                <p:tgtEl>
                  <p:spTgt spid="4"/>
                </p:tgtEl>
              </p:cMediaNode>
            </p:video>
            <p:seq concurrent="1" nextAc="seek">
              <p:cTn id="8" restart="whenNotActive" fill="hold" evtFilter="cancelBubble" nodeType="interactiveSeq">
                <p:stCondLst>
                  <p:cond evt="onClick" delay="0">
                    <p:tgtEl>
                      <p:spTgt spid="4"/>
                    </p:tgtEl>
                  </p:cond>
                </p:stCondLst>
                <p:endSync evt="end" delay="0">
                  <p:rtn val="all"/>
                </p:endSync>
                <p:childTnLst>
                  <p:par>
                    <p:cTn id="9" fill="hold">
                      <p:stCondLst>
                        <p:cond delay="0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2" presetClass="mediacall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cmd type="call" cmd="togglePause">
                                      <p:cBhvr>
                                        <p:cTn id="12" dur="1" fill="hold"/>
                                        <p:tgtEl>
                                          <p:spTgt spid="4"/>
                                        </p:tgtEl>
                                      </p:cBhvr>
                                    </p:cmd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nextCondLst>
                <p:cond evt="onClick" delay="0">
                  <p:tgtEl>
                    <p:spTgt spid="4"/>
                  </p:tgtEl>
                </p:cond>
              </p:nextCondLst>
            </p:seq>
          </p:childTnLst>
        </p:cTn>
      </p:par>
    </p:tnLst>
  </p:timing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PRESGUID" val="65a9539e-22c3-413b-af79-be76ca384c95"/>
</p:tagLst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 Them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Metadata/LabelInfo.xml><?xml version="1.0" encoding="utf-8"?>
<clbl:labelList xmlns:clbl="http://schemas.microsoft.com/office/2020/mipLabelMetadata">
  <clbl:label id="{eaab77ea-b4a5-49e3-a1e8-d6dd23a1f286}" enabled="0" method="" siteId="{eaab77ea-b4a5-49e3-a1e8-d6dd23a1f286}" removed="1"/>
</clbl:labelList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</TotalTime>
  <Words>59</Words>
  <Application>Microsoft Office PowerPoint</Application>
  <PresentationFormat>Widescreen</PresentationFormat>
  <Paragraphs>2</Paragraphs>
  <Slides>1</Slides>
  <Notes>0</Notes>
  <HiddenSlides>0</HiddenSlides>
  <MMClips>1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Symbol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erek Brazil</dc:creator>
  <cp:lastModifiedBy>Derek Brazil</cp:lastModifiedBy>
  <cp:revision>5</cp:revision>
  <cp:lastPrinted>2025-01-07T16:23:51Z</cp:lastPrinted>
  <dcterms:created xsi:type="dcterms:W3CDTF">2024-07-31T10:31:56Z</dcterms:created>
  <dcterms:modified xsi:type="dcterms:W3CDTF">2025-09-15T12:06:50Z</dcterms:modified>
</cp:coreProperties>
</file>